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014" y="118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usi\Desktop\Manuscripts\Frontiers%20article\Stats%20for%20Tissue%20Localization%20Gel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usi\Desktop\Manuscripts\Frontiers%20article\Stats%20for%20Tissue%20Localization%20Gel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usi\Desktop\Manuscripts\Frontiers%20article\Stats%20for%20Tissue%20Localization%20Gel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PLAFP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M$51:$M$54</c:f>
                <c:numCache>
                  <c:formatCode>General</c:formatCode>
                  <c:ptCount val="4"/>
                  <c:pt idx="0">
                    <c:v>3.9468000000000003E-2</c:v>
                  </c:pt>
                  <c:pt idx="1">
                    <c:v>0.13156000000000001</c:v>
                  </c:pt>
                  <c:pt idx="2">
                    <c:v>6.5780000000000005E-2</c:v>
                  </c:pt>
                  <c:pt idx="3">
                    <c:v>6.5780000000000005E-2</c:v>
                  </c:pt>
                </c:numCache>
              </c:numRef>
            </c:plus>
            <c:minus>
              <c:numRef>
                <c:f>Sheet1!$M$51:$M$54</c:f>
                <c:numCache>
                  <c:formatCode>General</c:formatCode>
                  <c:ptCount val="4"/>
                  <c:pt idx="0">
                    <c:v>3.9468000000000003E-2</c:v>
                  </c:pt>
                  <c:pt idx="1">
                    <c:v>0.13156000000000001</c:v>
                  </c:pt>
                  <c:pt idx="2">
                    <c:v>6.5780000000000005E-2</c:v>
                  </c:pt>
                  <c:pt idx="3">
                    <c:v>6.5780000000000005E-2</c:v>
                  </c:pt>
                </c:numCache>
              </c:numRef>
            </c:minus>
          </c:errBars>
          <c:cat>
            <c:strRef>
              <c:f>Sheet1!$K$51:$K$54</c:f>
              <c:strCache>
                <c:ptCount val="4"/>
                <c:pt idx="0">
                  <c:v>Root</c:v>
                </c:pt>
                <c:pt idx="1">
                  <c:v>Stem</c:v>
                </c:pt>
                <c:pt idx="2">
                  <c:v>Leaf</c:v>
                </c:pt>
                <c:pt idx="3">
                  <c:v>Flower</c:v>
                </c:pt>
              </c:strCache>
            </c:strRef>
          </c:cat>
          <c:val>
            <c:numRef>
              <c:f>Sheet1!$L$51:$L$54</c:f>
              <c:numCache>
                <c:formatCode>General</c:formatCode>
                <c:ptCount val="4"/>
                <c:pt idx="0">
                  <c:v>0.56702360000000007</c:v>
                </c:pt>
                <c:pt idx="1">
                  <c:v>0.99985599999999997</c:v>
                </c:pt>
                <c:pt idx="2">
                  <c:v>0.9143420000000001</c:v>
                </c:pt>
                <c:pt idx="3">
                  <c:v>0.9406539999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1122432"/>
        <c:axId val="81124736"/>
      </c:barChart>
      <c:catAx>
        <c:axId val="8112243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81124736"/>
        <c:crosses val="autoZero"/>
        <c:auto val="1"/>
        <c:lblAlgn val="ctr"/>
        <c:lblOffset val="100"/>
        <c:noMultiLvlLbl val="0"/>
      </c:catAx>
      <c:valAx>
        <c:axId val="8112473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>
                    <a:latin typeface="Arial" panose="020B0604020202020204" pitchFamily="34" charset="0"/>
                    <a:cs typeface="Arial" panose="020B0604020202020204" pitchFamily="34" charset="0"/>
                  </a:rPr>
                  <a:t>Relative Gene Expressio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81122432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dirty="0" smtClean="0"/>
              <a:t>GDSL-lipase</a:t>
            </a:r>
            <a:endParaRPr lang="en-US" dirty="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L$30</c:f>
              <c:strCache>
                <c:ptCount val="1"/>
                <c:pt idx="0">
                  <c:v>GDSL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O$31:$O$34</c:f>
                <c:numCache>
                  <c:formatCode>General</c:formatCode>
                  <c:ptCount val="4"/>
                  <c:pt idx="0">
                    <c:v>0.10890323933945244</c:v>
                  </c:pt>
                  <c:pt idx="1">
                    <c:v>5.5589395432737304E-2</c:v>
                  </c:pt>
                  <c:pt idx="2">
                    <c:v>3.9775916840817473E-2</c:v>
                  </c:pt>
                  <c:pt idx="3">
                    <c:v>3.5815898876754015E-2</c:v>
                  </c:pt>
                </c:numCache>
              </c:numRef>
            </c:plus>
            <c:minus>
              <c:numRef>
                <c:f>Sheet1!$O$31:$O$34</c:f>
                <c:numCache>
                  <c:formatCode>General</c:formatCode>
                  <c:ptCount val="4"/>
                  <c:pt idx="0">
                    <c:v>0.10890323933945244</c:v>
                  </c:pt>
                  <c:pt idx="1">
                    <c:v>5.5589395432737304E-2</c:v>
                  </c:pt>
                  <c:pt idx="2">
                    <c:v>3.9775916840817473E-2</c:v>
                  </c:pt>
                  <c:pt idx="3">
                    <c:v>3.5815898876754015E-2</c:v>
                  </c:pt>
                </c:numCache>
              </c:numRef>
            </c:minus>
          </c:errBars>
          <c:cat>
            <c:strRef>
              <c:f>Sheet1!$K$31:$K$34</c:f>
              <c:strCache>
                <c:ptCount val="4"/>
                <c:pt idx="0">
                  <c:v>Root</c:v>
                </c:pt>
                <c:pt idx="1">
                  <c:v>Stem</c:v>
                </c:pt>
                <c:pt idx="2">
                  <c:v>Leaf</c:v>
                </c:pt>
                <c:pt idx="3">
                  <c:v>Flower</c:v>
                </c:pt>
              </c:strCache>
            </c:strRef>
          </c:cat>
          <c:val>
            <c:numRef>
              <c:f>Sheet1!$L$31:$L$34</c:f>
              <c:numCache>
                <c:formatCode>General</c:formatCode>
                <c:ptCount val="4"/>
                <c:pt idx="0">
                  <c:v>0.36107129973061575</c:v>
                </c:pt>
                <c:pt idx="1">
                  <c:v>1.0848474914145607</c:v>
                </c:pt>
                <c:pt idx="2">
                  <c:v>0.97755606920539118</c:v>
                </c:pt>
                <c:pt idx="3">
                  <c:v>0.8252360974386804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1179008"/>
        <c:axId val="81180544"/>
      </c:barChart>
      <c:catAx>
        <c:axId val="8117900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81180544"/>
        <c:crosses val="autoZero"/>
        <c:auto val="1"/>
        <c:lblAlgn val="ctr"/>
        <c:lblOffset val="100"/>
        <c:noMultiLvlLbl val="0"/>
      </c:catAx>
      <c:valAx>
        <c:axId val="8118054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>
                    <a:latin typeface="Arial" panose="020B0604020202020204" pitchFamily="34" charset="0"/>
                    <a:cs typeface="Arial" panose="020B0604020202020204" pitchFamily="34" charset="0"/>
                  </a:rPr>
                  <a:t>Relative Gene Expressio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81179008"/>
        <c:crosses val="autoZero"/>
        <c:crossBetween val="between"/>
      </c:valAx>
    </c:plotArea>
    <c:plotVisOnly val="1"/>
    <c:dispBlanksAs val="gap"/>
    <c:showDLblsOverMax val="0"/>
  </c:chart>
  <c:spPr>
    <a:ln w="9525">
      <a:solidFill>
        <a:schemeClr val="tx1"/>
      </a:solidFill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txPr>
        <a:bodyPr/>
        <a:lstStyle/>
        <a:p>
          <a:pPr>
            <a:defRPr sz="1400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M$30</c:f>
              <c:strCache>
                <c:ptCount val="1"/>
                <c:pt idx="0">
                  <c:v>PIG-P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P$31:$P$34</c:f>
                <c:numCache>
                  <c:formatCode>General</c:formatCode>
                  <c:ptCount val="4"/>
                  <c:pt idx="0">
                    <c:v>0.28167297522433132</c:v>
                  </c:pt>
                  <c:pt idx="1">
                    <c:v>6.9276462887402024E-2</c:v>
                  </c:pt>
                  <c:pt idx="2">
                    <c:v>8.3079212197122776E-2</c:v>
                  </c:pt>
                  <c:pt idx="3">
                    <c:v>0.12874440153374161</c:v>
                  </c:pt>
                </c:numCache>
              </c:numRef>
            </c:plus>
            <c:minus>
              <c:numRef>
                <c:f>Sheet1!$P$31:$P$34</c:f>
                <c:numCache>
                  <c:formatCode>General</c:formatCode>
                  <c:ptCount val="4"/>
                  <c:pt idx="0">
                    <c:v>0.28167297522433132</c:v>
                  </c:pt>
                  <c:pt idx="1">
                    <c:v>6.9276462887402024E-2</c:v>
                  </c:pt>
                  <c:pt idx="2">
                    <c:v>8.3079212197122776E-2</c:v>
                  </c:pt>
                  <c:pt idx="3">
                    <c:v>0.12874440153374161</c:v>
                  </c:pt>
                </c:numCache>
              </c:numRef>
            </c:minus>
          </c:errBars>
          <c:cat>
            <c:strRef>
              <c:f>Sheet1!$K$31:$K$34</c:f>
              <c:strCache>
                <c:ptCount val="4"/>
                <c:pt idx="0">
                  <c:v>Root</c:v>
                </c:pt>
                <c:pt idx="1">
                  <c:v>Stem</c:v>
                </c:pt>
                <c:pt idx="2">
                  <c:v>Leaf</c:v>
                </c:pt>
                <c:pt idx="3">
                  <c:v>Flower</c:v>
                </c:pt>
              </c:strCache>
            </c:strRef>
          </c:cat>
          <c:val>
            <c:numRef>
              <c:f>Sheet1!$M$31:$M$34</c:f>
              <c:numCache>
                <c:formatCode>General</c:formatCode>
                <c:ptCount val="4"/>
                <c:pt idx="0">
                  <c:v>0.94258800944510357</c:v>
                </c:pt>
                <c:pt idx="1">
                  <c:v>1.030053439842131</c:v>
                </c:pt>
                <c:pt idx="2">
                  <c:v>0.59627048276015548</c:v>
                </c:pt>
                <c:pt idx="3">
                  <c:v>0.9561971991039177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6591744"/>
        <c:axId val="86593536"/>
      </c:barChart>
      <c:catAx>
        <c:axId val="8659174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86593536"/>
        <c:crosses val="autoZero"/>
        <c:auto val="1"/>
        <c:lblAlgn val="ctr"/>
        <c:lblOffset val="100"/>
        <c:noMultiLvlLbl val="0"/>
      </c:catAx>
      <c:valAx>
        <c:axId val="8659353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>
                    <a:latin typeface="Arial" panose="020B0604020202020204" pitchFamily="34" charset="0"/>
                    <a:cs typeface="Arial" panose="020B0604020202020204" pitchFamily="34" charset="0"/>
                  </a:rPr>
                  <a:t>Relative Gene Expressio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86591744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1ED26-D01F-40E5-9CD1-E9562A7973B6}" type="datetimeFigureOut">
              <a:rPr lang="en-US" smtClean="0"/>
              <a:t>2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100B4-84A3-4E7E-A8FD-599D037ADA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69771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1ED26-D01F-40E5-9CD1-E9562A7973B6}" type="datetimeFigureOut">
              <a:rPr lang="en-US" smtClean="0"/>
              <a:t>2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100B4-84A3-4E7E-A8FD-599D037ADA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36614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1ED26-D01F-40E5-9CD1-E9562A7973B6}" type="datetimeFigureOut">
              <a:rPr lang="en-US" smtClean="0"/>
              <a:t>2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100B4-84A3-4E7E-A8FD-599D037ADA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73667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1ED26-D01F-40E5-9CD1-E9562A7973B6}" type="datetimeFigureOut">
              <a:rPr lang="en-US" smtClean="0"/>
              <a:t>2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100B4-84A3-4E7E-A8FD-599D037ADA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51385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1ED26-D01F-40E5-9CD1-E9562A7973B6}" type="datetimeFigureOut">
              <a:rPr lang="en-US" smtClean="0"/>
              <a:t>2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100B4-84A3-4E7E-A8FD-599D037ADA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34630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1ED26-D01F-40E5-9CD1-E9562A7973B6}" type="datetimeFigureOut">
              <a:rPr lang="en-US" smtClean="0"/>
              <a:t>2/1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100B4-84A3-4E7E-A8FD-599D037ADA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8799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1ED26-D01F-40E5-9CD1-E9562A7973B6}" type="datetimeFigureOut">
              <a:rPr lang="en-US" smtClean="0"/>
              <a:t>2/16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100B4-84A3-4E7E-A8FD-599D037ADA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2630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1ED26-D01F-40E5-9CD1-E9562A7973B6}" type="datetimeFigureOut">
              <a:rPr lang="en-US" smtClean="0"/>
              <a:t>2/1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100B4-84A3-4E7E-A8FD-599D037ADA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77386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1ED26-D01F-40E5-9CD1-E9562A7973B6}" type="datetimeFigureOut">
              <a:rPr lang="en-US" smtClean="0"/>
              <a:t>2/16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100B4-84A3-4E7E-A8FD-599D037ADA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77364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1ED26-D01F-40E5-9CD1-E9562A7973B6}" type="datetimeFigureOut">
              <a:rPr lang="en-US" smtClean="0"/>
              <a:t>2/1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100B4-84A3-4E7E-A8FD-599D037ADA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82858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1ED26-D01F-40E5-9CD1-E9562A7973B6}" type="datetimeFigureOut">
              <a:rPr lang="en-US" smtClean="0"/>
              <a:t>2/1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100B4-84A3-4E7E-A8FD-599D037ADA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8299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41ED26-D01F-40E5-9CD1-E9562A7973B6}" type="datetimeFigureOut">
              <a:rPr lang="en-US" smtClean="0"/>
              <a:t>2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4100B4-84A3-4E7E-A8FD-599D037ADA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49164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>
            <p:extLst>
              <p:ext uri="{D42A27DB-BD31-4B8C-83A1-F6EECF244321}">
                <p14:modId xmlns:p14="http://schemas.microsoft.com/office/powerpoint/2010/main" val="2781389717"/>
              </p:ext>
            </p:extLst>
          </p:nvPr>
        </p:nvGraphicFramePr>
        <p:xfrm>
          <a:off x="1525972" y="3842266"/>
          <a:ext cx="2674553" cy="19489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64037380"/>
              </p:ext>
            </p:extLst>
          </p:nvPr>
        </p:nvGraphicFramePr>
        <p:xfrm>
          <a:off x="1524000" y="1672888"/>
          <a:ext cx="2667000" cy="19847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66257306"/>
              </p:ext>
            </p:extLst>
          </p:nvPr>
        </p:nvGraphicFramePr>
        <p:xfrm>
          <a:off x="1525972" y="6019800"/>
          <a:ext cx="2684078" cy="1981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762001" y="609600"/>
            <a:ext cx="56388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rbaglia et al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, Supplementary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: </a:t>
            </a:r>
            <a:endParaRPr 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DSL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,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FP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, and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G-P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) expression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five-week ol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bidopsi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nts. Values represent mean and standard error of 3 biological replicates as determined using semiquantitative RT-PCR.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201844" y="168806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9" name="TextBox 8"/>
          <p:cNvSpPr txBox="1"/>
          <p:nvPr/>
        </p:nvSpPr>
        <p:spPr>
          <a:xfrm>
            <a:off x="1201844" y="384226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1219478" y="6019800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8830966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50FB4CD0F454C4A92D9C0FA6E32AAE3" ma:contentTypeVersion="7" ma:contentTypeDescription="Create a new document." ma:contentTypeScope="" ma:versionID="a5800d4522ad6bb42b1b471843bdcecc">
  <xsd:schema xmlns:xsd="http://www.w3.org/2001/XMLSchema" xmlns:p="http://schemas.microsoft.com/office/2006/metadata/properties" xmlns:ns2="ad5e6ac6-7e28-44ff-b599-4b096ee3745e" targetNamespace="http://schemas.microsoft.com/office/2006/metadata/properties" ma:root="true" ma:fieldsID="9c3be0cea3e8431379a50517fac3f2af" ns2:_="">
    <xsd:import namespace="ad5e6ac6-7e28-44ff-b599-4b096ee3745e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ad5e6ac6-7e28-44ff-b599-4b096ee3745e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ad5e6ac6-7e28-44ff-b599-4b096ee3745e">
      <UserInfo>
        <DisplayName/>
        <AccountId xsi:nil="true"/>
        <AccountType/>
      </UserInfo>
    </Checked_x0020_Out_x0020_To>
    <IsDeleted xmlns="ad5e6ac6-7e28-44ff-b599-4b096ee3745e">false</IsDeleted>
    <FileFormat xmlns="ad5e6ac6-7e28-44ff-b599-4b096ee3745e">PPTX</FileFormat>
    <TitleName xmlns="ad5e6ac6-7e28-44ff-b599-4b096ee3745e">Presentation 1.PPTX</TitleName>
    <StageName xmlns="ad5e6ac6-7e28-44ff-b599-4b096ee3745e" xsi:nil="true"/>
    <DocumentType xmlns="ad5e6ac6-7e28-44ff-b599-4b096ee3745e">Presentation</DocumentType>
    <DocumentId xmlns="ad5e6ac6-7e28-44ff-b599-4b096ee3745e">Presentation 1.PPTX</DocumentId>
  </documentManagement>
</p:properties>
</file>

<file path=customXml/itemProps1.xml><?xml version="1.0" encoding="utf-8"?>
<ds:datastoreItem xmlns:ds="http://schemas.openxmlformats.org/officeDocument/2006/customXml" ds:itemID="{1A8CEDB1-2C53-4673-AFD2-B4B1338E960A}"/>
</file>

<file path=customXml/itemProps2.xml><?xml version="1.0" encoding="utf-8"?>
<ds:datastoreItem xmlns:ds="http://schemas.openxmlformats.org/officeDocument/2006/customXml" ds:itemID="{854EBD78-65E1-401A-B6D0-6FFCAF14A013}"/>
</file>

<file path=customXml/itemProps3.xml><?xml version="1.0" encoding="utf-8"?>
<ds:datastoreItem xmlns:ds="http://schemas.openxmlformats.org/officeDocument/2006/customXml" ds:itemID="{CE6FF715-8237-406D-8294-5C5CA6CB3388}"/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59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sanne</dc:creator>
  <cp:lastModifiedBy>susanne</cp:lastModifiedBy>
  <cp:revision>2</cp:revision>
  <dcterms:created xsi:type="dcterms:W3CDTF">2016-02-16T18:23:32Z</dcterms:created>
  <dcterms:modified xsi:type="dcterms:W3CDTF">2016-02-16T18:33:2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50FB4CD0F454C4A92D9C0FA6E32AAE3</vt:lpwstr>
  </property>
</Properties>
</file>